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0204" y="-15240"/>
            <a:ext cx="6849587" cy="8720118"/>
            <a:chOff x="10204" y="-15240"/>
            <a:chExt cx="6849587" cy="872011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255"/>
            <a:stretch/>
          </p:blipFill>
          <p:spPr>
            <a:xfrm>
              <a:off x="10204" y="0"/>
              <a:ext cx="2260524" cy="745542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72" r="2288" b="65338"/>
            <a:stretch/>
          </p:blipFill>
          <p:spPr>
            <a:xfrm>
              <a:off x="4579886" y="4961206"/>
              <a:ext cx="2279905" cy="2584199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33" t="16639" r="52287"/>
            <a:stretch/>
          </p:blipFill>
          <p:spPr>
            <a:xfrm>
              <a:off x="2314087" y="0"/>
              <a:ext cx="2254064" cy="621493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39" t="33112" r="27385"/>
            <a:stretch/>
          </p:blipFill>
          <p:spPr>
            <a:xfrm>
              <a:off x="4561597" y="-15240"/>
              <a:ext cx="2273543" cy="4986766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33" r="52287" b="83241"/>
            <a:stretch/>
          </p:blipFill>
          <p:spPr>
            <a:xfrm>
              <a:off x="17824" y="7447802"/>
              <a:ext cx="2254064" cy="1249456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39" r="27385" b="66407"/>
            <a:stretch/>
          </p:blipFill>
          <p:spPr>
            <a:xfrm>
              <a:off x="2295768" y="6200362"/>
              <a:ext cx="2273543" cy="2504516"/>
            </a:xfrm>
            <a:prstGeom prst="rect">
              <a:avLst/>
            </a:prstGeom>
          </p:spPr>
        </p:pic>
      </p:grpSp>
      <p:sp>
        <p:nvSpPr>
          <p:cNvPr id="12" name="TextBox 11"/>
          <p:cNvSpPr txBox="1"/>
          <p:nvPr/>
        </p:nvSpPr>
        <p:spPr>
          <a:xfrm>
            <a:off x="-4123" y="9068633"/>
            <a:ext cx="6839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 SNP-index plots for 20 pseudomolecules of LLS susceptible bulk with resistant paren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lines indicate the sliding window average of 2Mb interval with 50 kb increment for SNP-index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2</TotalTime>
  <Words>33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0</cp:revision>
  <dcterms:created xsi:type="dcterms:W3CDTF">2015-04-20T11:32:42Z</dcterms:created>
  <dcterms:modified xsi:type="dcterms:W3CDTF">2016-09-26T10:48:53Z</dcterms:modified>
</cp:coreProperties>
</file>